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400800" cy="5018088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A984C0-EFD1-43C2-A47C-41EE493F1CB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20760" y="201600"/>
            <a:ext cx="5759280" cy="83664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20760" y="1171080"/>
            <a:ext cx="5759280" cy="158004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20760" y="2901600"/>
            <a:ext cx="5759280" cy="158004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9A02B4-CF14-486A-BA31-B6FF6CA178F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20760" y="201600"/>
            <a:ext cx="5759280" cy="83664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20760" y="1171080"/>
            <a:ext cx="2810520" cy="158004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272040" y="1171080"/>
            <a:ext cx="2810520" cy="158004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20760" y="2901600"/>
            <a:ext cx="2810520" cy="158004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272040" y="2901600"/>
            <a:ext cx="2810520" cy="158004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5216C6-32C3-47C6-8CBE-47E2E89B080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20760" y="201600"/>
            <a:ext cx="5759280" cy="83664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20760" y="1171080"/>
            <a:ext cx="1854360" cy="158004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268360" y="1171080"/>
            <a:ext cx="1854360" cy="158004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215600" y="1171080"/>
            <a:ext cx="1854360" cy="158004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20760" y="2901600"/>
            <a:ext cx="1854360" cy="158004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268360" y="2901600"/>
            <a:ext cx="1854360" cy="158004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215600" y="2901600"/>
            <a:ext cx="1854360" cy="158004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23BB6F-CBCD-4CD9-994A-923787BFF53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20760" y="201600"/>
            <a:ext cx="5759280" cy="83664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20760" y="1171080"/>
            <a:ext cx="5759280" cy="3313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550"/>
              </a:spcBef>
              <a:buNone/>
              <a:tabLst>
                <a:tab algn="l" pos="0"/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F74600-D0AF-466C-8028-28EBF9C3333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20760" y="201600"/>
            <a:ext cx="5759280" cy="83664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20760" y="1171080"/>
            <a:ext cx="5759280" cy="331308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CD2766-7A14-47F6-A10D-FEBE159E589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20760" y="201600"/>
            <a:ext cx="5759280" cy="83664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20760" y="1171080"/>
            <a:ext cx="2810520" cy="331308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272040" y="1171080"/>
            <a:ext cx="2810520" cy="331308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1ADE9E-E0A0-4863-83DF-E7B9725B350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20760" y="201600"/>
            <a:ext cx="5759280" cy="83664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6C9928-6F97-48F3-82DC-C205CB5884E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20760" y="201600"/>
            <a:ext cx="5759280" cy="3879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550"/>
              </a:spcBef>
              <a:tabLst>
                <a:tab algn="l" pos="0"/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EC5902-1504-4D52-AB2A-09DD7D93BE7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20760" y="201600"/>
            <a:ext cx="5759280" cy="83664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20760" y="1171080"/>
            <a:ext cx="2810520" cy="158004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272040" y="1171080"/>
            <a:ext cx="2810520" cy="331308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20760" y="2901600"/>
            <a:ext cx="2810520" cy="158004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5E9685-0F39-4A9D-9BEC-5A86779023F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20760" y="201600"/>
            <a:ext cx="5759280" cy="83664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20760" y="1171080"/>
            <a:ext cx="2810520" cy="331308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272040" y="1171080"/>
            <a:ext cx="2810520" cy="158004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272040" y="2901600"/>
            <a:ext cx="2810520" cy="158004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B4099A-1EF3-4E3A-BBE9-521B141EBD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20760" y="201600"/>
            <a:ext cx="5759280" cy="83664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20760" y="1171080"/>
            <a:ext cx="2810520" cy="158004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272040" y="1171080"/>
            <a:ext cx="2810520" cy="158004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20760" y="2901600"/>
            <a:ext cx="5759280" cy="158004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8ADDF1-45D2-45B2-87D9-8D9426F54E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20760" y="201600"/>
            <a:ext cx="5759280" cy="83664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</a:pPr>
            <a:r>
              <a:rPr b="0" lang="en-US" sz="31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20760" y="1171080"/>
            <a:ext cx="5759280" cy="331308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t">
            <a:normAutofit/>
          </a:bodyPr>
          <a:p>
            <a:pPr marL="237960" indent="-237960">
              <a:spcBef>
                <a:spcPts val="550"/>
              </a:spcBef>
              <a:buClr>
                <a:srgbClr val="000000"/>
              </a:buClr>
              <a:buFont typeface="Arial"/>
              <a:buChar char="•"/>
              <a:tabLst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  <a:p>
            <a:pPr lvl="1" marL="517680" indent="-198720">
              <a:spcBef>
                <a:spcPts val="550"/>
              </a:spcBef>
              <a:buClr>
                <a:srgbClr val="000000"/>
              </a:buClr>
              <a:buFont typeface="Arial"/>
              <a:buChar char="–"/>
              <a:tabLst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  <a:p>
            <a:pPr lvl="2" marL="795240" indent="-158760">
              <a:spcBef>
                <a:spcPts val="550"/>
              </a:spcBef>
              <a:buClr>
                <a:srgbClr val="000000"/>
              </a:buClr>
              <a:buFont typeface="Arial"/>
              <a:buChar char="•"/>
              <a:tabLst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  <a:p>
            <a:pPr lvl="3" marL="1114560" indent="-158760">
              <a:spcBef>
                <a:spcPts val="550"/>
              </a:spcBef>
              <a:buClr>
                <a:srgbClr val="000000"/>
              </a:buClr>
              <a:buFont typeface="Arial"/>
              <a:buChar char="–"/>
              <a:tabLst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  <a:p>
            <a:pPr lvl="4" marL="1433520" indent="-158760">
              <a:spcBef>
                <a:spcPts val="550"/>
              </a:spcBef>
              <a:buClr>
                <a:srgbClr val="000000"/>
              </a:buClr>
              <a:buFont typeface="Arial"/>
              <a:buChar char="»"/>
              <a:tabLst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  <a:p>
            <a:pPr lvl="5" marL="1433520" indent="-158760">
              <a:spcBef>
                <a:spcPts val="550"/>
              </a:spcBef>
              <a:buClr>
                <a:srgbClr val="000000"/>
              </a:buClr>
              <a:buFont typeface="Arial"/>
              <a:buChar char="»"/>
              <a:tabLst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  <a:p>
            <a:pPr lvl="6" marL="1433520" indent="-158760">
              <a:spcBef>
                <a:spcPts val="550"/>
              </a:spcBef>
              <a:buClr>
                <a:srgbClr val="000000"/>
              </a:buClr>
              <a:buFont typeface="Arial"/>
              <a:buChar char="»"/>
              <a:tabLst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20400" y="4652640"/>
            <a:ext cx="1492200" cy="26676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ctr">
            <a:noAutofit/>
          </a:bodyPr>
          <a:lstStyle>
            <a:lvl1pPr indent="0">
              <a:buNone/>
              <a:tabLst>
                <a:tab algn="l" pos="0"/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  <a:defRPr b="0" lang="en-US" sz="8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</a:pPr>
            <a:fld id="{F1C49A51-3DCB-4B63-8FF7-6B5279E312A8}" type="datetime">
              <a:rPr b="0" lang="en-US" sz="8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187720" y="4652640"/>
            <a:ext cx="2025360" cy="26676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ctr">
            <a:noAutofit/>
          </a:bodyPr>
          <a:p>
            <a:pPr indent="0">
              <a:buNone/>
              <a:tabLst>
                <a:tab algn="l" pos="0"/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</a:pP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587480" y="4652640"/>
            <a:ext cx="1492200" cy="266760"/>
          </a:xfrm>
          <a:prstGeom prst="rect">
            <a:avLst/>
          </a:prstGeom>
          <a:noFill/>
          <a:ln w="0">
            <a:noFill/>
          </a:ln>
        </p:spPr>
        <p:txBody>
          <a:bodyPr lIns="63720" rIns="63720" tIns="32040" bIns="32040" anchor="ctr">
            <a:noAutofit/>
          </a:bodyPr>
          <a:lstStyle>
            <a:lvl1pPr indent="0" algn="r">
              <a:buNone/>
              <a:tabLst>
                <a:tab algn="l" pos="0"/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  <a:defRPr b="0" lang="en-US" sz="8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636480"/>
                <a:tab algn="l" pos="1273320"/>
                <a:tab algn="l" pos="1909800"/>
                <a:tab algn="l" pos="2546280"/>
                <a:tab algn="l" pos="3182760"/>
                <a:tab algn="l" pos="3819600"/>
                <a:tab algn="l" pos="4456080"/>
                <a:tab algn="l" pos="5092560"/>
                <a:tab algn="l" pos="5729400"/>
                <a:tab algn="l" pos="6365880"/>
                <a:tab algn="l" pos="7002360"/>
                <a:tab algn="l" pos="7639200"/>
                <a:tab algn="l" pos="8275680"/>
                <a:tab algn="l" pos="8912160"/>
                <a:tab algn="l" pos="9548640"/>
                <a:tab algn="l" pos="10185480"/>
                <a:tab algn="l" pos="10821960"/>
              </a:tabLst>
            </a:pPr>
            <a:fld id="{24B429C3-C1C4-4BFF-8B88-5F45ECD502B1}" type="slidenum">
              <a:rPr b="0" lang="en-US" sz="8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96"/>
          <p:cNvGrpSpPr/>
          <p:nvPr/>
        </p:nvGrpSpPr>
        <p:grpSpPr>
          <a:xfrm>
            <a:off x="-19800" y="-69840"/>
            <a:ext cx="6422760" cy="5089320"/>
            <a:chOff x="-19800" y="-69840"/>
            <a:chExt cx="6422760" cy="5089320"/>
          </a:xfrm>
        </p:grpSpPr>
        <p:pic>
          <p:nvPicPr>
            <p:cNvPr id="42" name="Picture 2" descr=""/>
            <p:cNvPicPr/>
            <p:nvPr/>
          </p:nvPicPr>
          <p:blipFill>
            <a:blip r:embed="rId1"/>
            <a:stretch/>
          </p:blipFill>
          <p:spPr>
            <a:xfrm>
              <a:off x="808200" y="13320"/>
              <a:ext cx="1371960" cy="1349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Picture 2" descr=""/>
            <p:cNvPicPr/>
            <p:nvPr/>
          </p:nvPicPr>
          <p:blipFill>
            <a:blip r:embed="rId2"/>
            <a:srcRect l="7777" t="35329" r="10001" b="10266"/>
            <a:stretch/>
          </p:blipFill>
          <p:spPr>
            <a:xfrm>
              <a:off x="325080" y="1677960"/>
              <a:ext cx="5640120" cy="2332800"/>
            </a:xfrm>
            <a:prstGeom prst="rect">
              <a:avLst/>
            </a:prstGeom>
            <a:ln w="6480">
              <a:solidFill>
                <a:srgbClr val="000000"/>
              </a:solidFill>
              <a:prstDash val="sysDot"/>
              <a:miter/>
            </a:ln>
          </p:spPr>
        </p:pic>
        <p:sp>
          <p:nvSpPr>
            <p:cNvPr id="44" name="Straight Connector 99"/>
            <p:cNvSpPr/>
            <p:nvPr/>
          </p:nvSpPr>
          <p:spPr>
            <a:xfrm>
              <a:off x="377640" y="3830040"/>
              <a:ext cx="585000" cy="18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TextBox 100"/>
            <p:cNvSpPr/>
            <p:nvPr/>
          </p:nvSpPr>
          <p:spPr>
            <a:xfrm>
              <a:off x="405720" y="3794400"/>
              <a:ext cx="573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636480"/>
                  <a:tab algn="l" pos="1273320"/>
                  <a:tab algn="l" pos="1909800"/>
                  <a:tab algn="l" pos="2546280"/>
                  <a:tab algn="l" pos="3182760"/>
                  <a:tab algn="l" pos="3819600"/>
                  <a:tab algn="l" pos="4456080"/>
                  <a:tab algn="l" pos="5092560"/>
                  <a:tab algn="l" pos="5729400"/>
                  <a:tab algn="l" pos="6365880"/>
                  <a:tab algn="l" pos="7002360"/>
                  <a:tab algn="l" pos="7639200"/>
                  <a:tab algn="l" pos="8275680"/>
                  <a:tab algn="l" pos="8912160"/>
                  <a:tab algn="l" pos="9548640"/>
                  <a:tab algn="l" pos="10185480"/>
                  <a:tab algn="l" pos="1082196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Calibri"/>
                </a:rPr>
                <a:t>20 miles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TextBox 101"/>
            <p:cNvSpPr/>
            <p:nvPr/>
          </p:nvSpPr>
          <p:spPr>
            <a:xfrm>
              <a:off x="3163680" y="2227320"/>
              <a:ext cx="372600" cy="154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636480"/>
                  <a:tab algn="l" pos="1273320"/>
                  <a:tab algn="l" pos="1909800"/>
                  <a:tab algn="l" pos="2546280"/>
                  <a:tab algn="l" pos="3182760"/>
                  <a:tab algn="l" pos="3819600"/>
                  <a:tab algn="l" pos="4456080"/>
                  <a:tab algn="l" pos="5092560"/>
                  <a:tab algn="l" pos="5729400"/>
                  <a:tab algn="l" pos="6365880"/>
                  <a:tab algn="l" pos="7002360"/>
                  <a:tab algn="l" pos="7639200"/>
                  <a:tab algn="l" pos="8275680"/>
                  <a:tab algn="l" pos="8912160"/>
                  <a:tab algn="l" pos="9548640"/>
                  <a:tab algn="l" pos="10185480"/>
                  <a:tab algn="l" pos="10821960"/>
                </a:tabLst>
              </a:pPr>
              <a:r>
                <a:rPr b="1" lang="en-US" sz="400" spc="-1" strike="noStrike">
                  <a:solidFill>
                    <a:srgbClr val="000000"/>
                  </a:solidFill>
                  <a:latin typeface="Calibri"/>
                </a:rPr>
                <a:t>Masingbi</a:t>
              </a:r>
              <a:endParaRPr b="0" lang="en-US" sz="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TextBox 102"/>
            <p:cNvSpPr/>
            <p:nvPr/>
          </p:nvSpPr>
          <p:spPr>
            <a:xfrm>
              <a:off x="3607560" y="2179800"/>
              <a:ext cx="406440" cy="154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636480"/>
                  <a:tab algn="l" pos="1273320"/>
                  <a:tab algn="l" pos="1909800"/>
                  <a:tab algn="l" pos="2546280"/>
                  <a:tab algn="l" pos="3182760"/>
                  <a:tab algn="l" pos="3819600"/>
                  <a:tab algn="l" pos="4456080"/>
                  <a:tab algn="l" pos="5092560"/>
                  <a:tab algn="l" pos="5729400"/>
                  <a:tab algn="l" pos="6365880"/>
                  <a:tab algn="l" pos="7002360"/>
                  <a:tab algn="l" pos="7639200"/>
                  <a:tab algn="l" pos="8275680"/>
                  <a:tab algn="l" pos="8912160"/>
                  <a:tab algn="l" pos="9548640"/>
                  <a:tab algn="l" pos="10185480"/>
                  <a:tab algn="l" pos="10821960"/>
                </a:tabLst>
              </a:pPr>
              <a:r>
                <a:rPr b="1" lang="en-US" sz="400" spc="-1" strike="noStrike">
                  <a:solidFill>
                    <a:srgbClr val="000000"/>
                  </a:solidFill>
                  <a:latin typeface="Calibri"/>
                </a:rPr>
                <a:t>Mabineh 1</a:t>
              </a:r>
              <a:endParaRPr b="0" lang="en-US" sz="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Freeform 103"/>
            <p:cNvSpPr/>
            <p:nvPr/>
          </p:nvSpPr>
          <p:spPr>
            <a:xfrm>
              <a:off x="3484080" y="2316240"/>
              <a:ext cx="159480" cy="142560"/>
            </a:xfrm>
            <a:prstGeom prst="pie">
              <a:avLst/>
            </a:prstGeom>
            <a:noFill/>
            <a:ln w="28440">
              <a:solidFill>
                <a:srgbClr val="984807"/>
              </a:solidFill>
              <a:miter/>
              <a:tailEnd len="med" type="triangle" w="med"/>
            </a:ln>
            <a:effectLst>
              <a:outerShdw dist="38183" dir="2700000" blurRad="0" rotWithShape="0">
                <a:srgbClr val="80808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636480"/>
                  <a:tab algn="l" pos="1273320"/>
                  <a:tab algn="l" pos="1909800"/>
                  <a:tab algn="l" pos="2546280"/>
                  <a:tab algn="l" pos="3182760"/>
                  <a:tab algn="l" pos="3819600"/>
                  <a:tab algn="l" pos="4456080"/>
                  <a:tab algn="l" pos="5092560"/>
                  <a:tab algn="l" pos="5729400"/>
                  <a:tab algn="l" pos="6365880"/>
                  <a:tab algn="l" pos="7002360"/>
                  <a:tab algn="l" pos="7639200"/>
                  <a:tab algn="l" pos="8275680"/>
                  <a:tab algn="l" pos="8912160"/>
                  <a:tab algn="l" pos="9548640"/>
                  <a:tab algn="l" pos="10185480"/>
                  <a:tab algn="l" pos="10821960"/>
                </a:tabLst>
              </a:pP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Freeform 104"/>
            <p:cNvSpPr/>
            <p:nvPr/>
          </p:nvSpPr>
          <p:spPr>
            <a:xfrm>
              <a:off x="3545640" y="2345040"/>
              <a:ext cx="1233720" cy="1131840"/>
            </a:xfrm>
            <a:prstGeom prst="pie">
              <a:avLst/>
            </a:prstGeom>
            <a:noFill/>
            <a:ln w="28440">
              <a:solidFill>
                <a:srgbClr val="4f81bd"/>
              </a:solidFill>
              <a:prstDash val="sysDot"/>
              <a:miter/>
              <a:tailEnd len="med" type="triangle" w="med"/>
            </a:ln>
            <a:effectLst>
              <a:outerShdw dist="38183" dir="2700000" blurRad="0" rotWithShape="0">
                <a:srgbClr val="80808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636480"/>
                  <a:tab algn="l" pos="1273320"/>
                  <a:tab algn="l" pos="1909800"/>
                  <a:tab algn="l" pos="2546280"/>
                  <a:tab algn="l" pos="3182760"/>
                  <a:tab algn="l" pos="3819600"/>
                  <a:tab algn="l" pos="4456080"/>
                  <a:tab algn="l" pos="5092560"/>
                  <a:tab algn="l" pos="5729400"/>
                  <a:tab algn="l" pos="6365880"/>
                  <a:tab algn="l" pos="7002360"/>
                  <a:tab algn="l" pos="7639200"/>
                  <a:tab algn="l" pos="8275680"/>
                  <a:tab algn="l" pos="8912160"/>
                  <a:tab algn="l" pos="9548640"/>
                  <a:tab algn="l" pos="10185480"/>
                  <a:tab algn="l" pos="10821960"/>
                </a:tabLst>
              </a:pP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TextBox 105"/>
            <p:cNvSpPr/>
            <p:nvPr/>
          </p:nvSpPr>
          <p:spPr>
            <a:xfrm>
              <a:off x="4755960" y="3264480"/>
              <a:ext cx="311760" cy="154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636480"/>
                  <a:tab algn="l" pos="1273320"/>
                  <a:tab algn="l" pos="1909800"/>
                  <a:tab algn="l" pos="2546280"/>
                  <a:tab algn="l" pos="3182760"/>
                  <a:tab algn="l" pos="3819600"/>
                  <a:tab algn="l" pos="4456080"/>
                  <a:tab algn="l" pos="5092560"/>
                  <a:tab algn="l" pos="5729400"/>
                  <a:tab algn="l" pos="6365880"/>
                  <a:tab algn="l" pos="7002360"/>
                  <a:tab algn="l" pos="7639200"/>
                  <a:tab algn="l" pos="8275680"/>
                  <a:tab algn="l" pos="8912160"/>
                  <a:tab algn="l" pos="9548640"/>
                  <a:tab algn="l" pos="10185480"/>
                  <a:tab algn="l" pos="10821960"/>
                </a:tabLst>
              </a:pPr>
              <a:r>
                <a:rPr b="1" lang="en-US" sz="400" spc="-1" strike="noStrike">
                  <a:solidFill>
                    <a:srgbClr val="000000"/>
                  </a:solidFill>
                  <a:latin typeface="Calibri"/>
                </a:rPr>
                <a:t>Tongo</a:t>
              </a:r>
              <a:endParaRPr b="0" lang="en-US" sz="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Oval 106"/>
            <p:cNvSpPr/>
            <p:nvPr/>
          </p:nvSpPr>
          <p:spPr>
            <a:xfrm>
              <a:off x="4775760" y="3331080"/>
              <a:ext cx="45720" cy="4572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ctr">
              <a:noAutofit/>
            </a:bodyPr>
            <a:p>
              <a:pPr algn="ctr">
                <a:tabLst>
                  <a:tab algn="l" pos="0"/>
                  <a:tab algn="l" pos="636480"/>
                  <a:tab algn="l" pos="1273320"/>
                  <a:tab algn="l" pos="1909800"/>
                  <a:tab algn="l" pos="2546280"/>
                  <a:tab algn="l" pos="3182760"/>
                  <a:tab algn="l" pos="3819600"/>
                  <a:tab algn="l" pos="4456080"/>
                  <a:tab algn="l" pos="5092560"/>
                  <a:tab algn="l" pos="5729400"/>
                  <a:tab algn="l" pos="6365880"/>
                  <a:tab algn="l" pos="7002360"/>
                  <a:tab algn="l" pos="7639200"/>
                  <a:tab algn="l" pos="8275680"/>
                  <a:tab algn="l" pos="8912160"/>
                  <a:tab algn="l" pos="9548640"/>
                  <a:tab algn="l" pos="10185480"/>
                  <a:tab algn="l" pos="10821960"/>
                </a:tabLst>
              </a:pP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Rectangle 107"/>
            <p:cNvSpPr/>
            <p:nvPr/>
          </p:nvSpPr>
          <p:spPr>
            <a:xfrm>
              <a:off x="725400" y="2911680"/>
              <a:ext cx="255960" cy="99720"/>
            </a:xfrm>
            <a:prstGeom prst="rect">
              <a:avLst/>
            </a:prstGeom>
            <a:noFill/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636480"/>
                  <a:tab algn="l" pos="1273320"/>
                  <a:tab algn="l" pos="1909800"/>
                  <a:tab algn="l" pos="2546280"/>
                  <a:tab algn="l" pos="3182760"/>
                  <a:tab algn="l" pos="3819600"/>
                  <a:tab algn="l" pos="4456080"/>
                  <a:tab algn="l" pos="5092560"/>
                  <a:tab algn="l" pos="5729400"/>
                  <a:tab algn="l" pos="6365880"/>
                  <a:tab algn="l" pos="7002360"/>
                  <a:tab algn="l" pos="7639200"/>
                  <a:tab algn="l" pos="8275680"/>
                  <a:tab algn="l" pos="8912160"/>
                  <a:tab algn="l" pos="9548640"/>
                  <a:tab algn="l" pos="10185480"/>
                  <a:tab algn="l" pos="10821960"/>
                </a:tabLst>
              </a:pP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Oval 108"/>
            <p:cNvSpPr/>
            <p:nvPr/>
          </p:nvSpPr>
          <p:spPr>
            <a:xfrm>
              <a:off x="811080" y="2988000"/>
              <a:ext cx="45720" cy="4572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ctr">
              <a:noAutofit/>
            </a:bodyPr>
            <a:p>
              <a:pPr algn="ctr">
                <a:tabLst>
                  <a:tab algn="l" pos="0"/>
                  <a:tab algn="l" pos="636480"/>
                  <a:tab algn="l" pos="1273320"/>
                  <a:tab algn="l" pos="1909800"/>
                  <a:tab algn="l" pos="2546280"/>
                  <a:tab algn="l" pos="3182760"/>
                  <a:tab algn="l" pos="3819600"/>
                  <a:tab algn="l" pos="4456080"/>
                  <a:tab algn="l" pos="5092560"/>
                  <a:tab algn="l" pos="5729400"/>
                  <a:tab algn="l" pos="6365880"/>
                  <a:tab algn="l" pos="7002360"/>
                  <a:tab algn="l" pos="7639200"/>
                  <a:tab algn="l" pos="8275680"/>
                  <a:tab algn="l" pos="8912160"/>
                  <a:tab algn="l" pos="9548640"/>
                  <a:tab algn="l" pos="10185480"/>
                  <a:tab algn="l" pos="10821960"/>
                </a:tabLst>
              </a:pP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Freeform 109"/>
            <p:cNvSpPr/>
            <p:nvPr/>
          </p:nvSpPr>
          <p:spPr>
            <a:xfrm>
              <a:off x="868320" y="1930680"/>
              <a:ext cx="2615040" cy="1099440"/>
            </a:xfrm>
            <a:prstGeom prst="pie">
              <a:avLst/>
            </a:prstGeom>
            <a:noFill/>
            <a:ln w="25560">
              <a:solidFill>
                <a:srgbClr val="000000"/>
              </a:solidFill>
              <a:miter/>
              <a:tailEnd len="med" type="triangle" w="med"/>
            </a:ln>
            <a:effectLst>
              <a:outerShdw dist="20160" dir="5400000" blurRad="0" rotWithShape="0">
                <a:srgbClr val="80808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636480"/>
                  <a:tab algn="l" pos="1273320"/>
                  <a:tab algn="l" pos="1909800"/>
                  <a:tab algn="l" pos="2546280"/>
                  <a:tab algn="l" pos="3182760"/>
                  <a:tab algn="l" pos="3819600"/>
                  <a:tab algn="l" pos="4456080"/>
                  <a:tab algn="l" pos="5092560"/>
                  <a:tab algn="l" pos="5729400"/>
                  <a:tab algn="l" pos="6365880"/>
                  <a:tab algn="l" pos="7002360"/>
                  <a:tab algn="l" pos="7639200"/>
                  <a:tab algn="l" pos="8275680"/>
                  <a:tab algn="l" pos="8912160"/>
                  <a:tab algn="l" pos="9548640"/>
                  <a:tab algn="l" pos="10185480"/>
                  <a:tab algn="l" pos="10821960"/>
                </a:tabLst>
              </a:pP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Freeform 110"/>
            <p:cNvSpPr/>
            <p:nvPr/>
          </p:nvSpPr>
          <p:spPr>
            <a:xfrm>
              <a:off x="877680" y="1877400"/>
              <a:ext cx="2705760" cy="1116720"/>
            </a:xfrm>
            <a:prstGeom prst="pie">
              <a:avLst/>
            </a:prstGeom>
            <a:noFill/>
            <a:ln w="19080">
              <a:solidFill>
                <a:srgbClr val="000000"/>
              </a:solidFill>
              <a:prstDash val="sysDot"/>
              <a:miter/>
              <a:tailEnd len="sm" type="triangle" w="med"/>
            </a:ln>
            <a:effectLst>
              <a:outerShdw dist="38183" dir="2700000" blurRad="0" rotWithShape="0">
                <a:srgbClr val="80808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636480"/>
                  <a:tab algn="l" pos="1273320"/>
                  <a:tab algn="l" pos="1909800"/>
                  <a:tab algn="l" pos="2546280"/>
                  <a:tab algn="l" pos="3182760"/>
                  <a:tab algn="l" pos="3819600"/>
                  <a:tab algn="l" pos="4456080"/>
                  <a:tab algn="l" pos="5092560"/>
                  <a:tab algn="l" pos="5729400"/>
                  <a:tab algn="l" pos="6365880"/>
                  <a:tab algn="l" pos="7002360"/>
                  <a:tab algn="l" pos="7639200"/>
                  <a:tab algn="l" pos="8275680"/>
                  <a:tab algn="l" pos="8912160"/>
                  <a:tab algn="l" pos="9548640"/>
                  <a:tab algn="l" pos="10185480"/>
                  <a:tab algn="l" pos="10821960"/>
                </a:tabLst>
              </a:pP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Rectangle 111"/>
            <p:cNvSpPr/>
            <p:nvPr/>
          </p:nvSpPr>
          <p:spPr>
            <a:xfrm>
              <a:off x="3221640" y="2259360"/>
              <a:ext cx="292680" cy="99720"/>
            </a:xfrm>
            <a:prstGeom prst="rect">
              <a:avLst/>
            </a:prstGeom>
            <a:noFill/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636480"/>
                  <a:tab algn="l" pos="1273320"/>
                  <a:tab algn="l" pos="1909800"/>
                  <a:tab algn="l" pos="2546280"/>
                  <a:tab algn="l" pos="3182760"/>
                  <a:tab algn="l" pos="3819600"/>
                  <a:tab algn="l" pos="4456080"/>
                  <a:tab algn="l" pos="5092560"/>
                  <a:tab algn="l" pos="5729400"/>
                  <a:tab algn="l" pos="6365880"/>
                  <a:tab algn="l" pos="7002360"/>
                  <a:tab algn="l" pos="7639200"/>
                  <a:tab algn="l" pos="8275680"/>
                  <a:tab algn="l" pos="8912160"/>
                  <a:tab algn="l" pos="9548640"/>
                  <a:tab algn="l" pos="10185480"/>
                  <a:tab algn="l" pos="10821960"/>
                </a:tabLst>
              </a:pP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Oval 112"/>
            <p:cNvSpPr/>
            <p:nvPr/>
          </p:nvSpPr>
          <p:spPr>
            <a:xfrm>
              <a:off x="3466800" y="2342880"/>
              <a:ext cx="45720" cy="4572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ctr">
              <a:noAutofit/>
            </a:bodyPr>
            <a:p>
              <a:pPr algn="ctr">
                <a:tabLst>
                  <a:tab algn="l" pos="0"/>
                  <a:tab algn="l" pos="636480"/>
                  <a:tab algn="l" pos="1273320"/>
                  <a:tab algn="l" pos="1909800"/>
                  <a:tab algn="l" pos="2546280"/>
                  <a:tab algn="l" pos="3182760"/>
                  <a:tab algn="l" pos="3819600"/>
                  <a:tab algn="l" pos="4456080"/>
                  <a:tab algn="l" pos="5092560"/>
                  <a:tab algn="l" pos="5729400"/>
                  <a:tab algn="l" pos="6365880"/>
                  <a:tab algn="l" pos="7002360"/>
                  <a:tab algn="l" pos="7639200"/>
                  <a:tab algn="l" pos="8275680"/>
                  <a:tab algn="l" pos="8912160"/>
                  <a:tab algn="l" pos="9548640"/>
                  <a:tab algn="l" pos="10185480"/>
                  <a:tab algn="l" pos="10821960"/>
                </a:tabLst>
              </a:pP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Rectangle 113"/>
            <p:cNvSpPr/>
            <p:nvPr/>
          </p:nvSpPr>
          <p:spPr>
            <a:xfrm>
              <a:off x="3678840" y="2213640"/>
              <a:ext cx="310680" cy="99720"/>
            </a:xfrm>
            <a:prstGeom prst="rect">
              <a:avLst/>
            </a:prstGeom>
            <a:noFill/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636480"/>
                  <a:tab algn="l" pos="1273320"/>
                  <a:tab algn="l" pos="1909800"/>
                  <a:tab algn="l" pos="2546280"/>
                  <a:tab algn="l" pos="3182760"/>
                  <a:tab algn="l" pos="3819600"/>
                  <a:tab algn="l" pos="4456080"/>
                  <a:tab algn="l" pos="5092560"/>
                  <a:tab algn="l" pos="5729400"/>
                  <a:tab algn="l" pos="6365880"/>
                  <a:tab algn="l" pos="7002360"/>
                  <a:tab algn="l" pos="7639200"/>
                  <a:tab algn="l" pos="8275680"/>
                  <a:tab algn="l" pos="8912160"/>
                  <a:tab algn="l" pos="9548640"/>
                  <a:tab algn="l" pos="10185480"/>
                  <a:tab algn="l" pos="10821960"/>
                </a:tabLst>
              </a:pP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Rectangle 114"/>
            <p:cNvSpPr/>
            <p:nvPr/>
          </p:nvSpPr>
          <p:spPr>
            <a:xfrm>
              <a:off x="4832280" y="3297600"/>
              <a:ext cx="200880" cy="99720"/>
            </a:xfrm>
            <a:prstGeom prst="rect">
              <a:avLst/>
            </a:prstGeom>
            <a:noFill/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636480"/>
                  <a:tab algn="l" pos="1273320"/>
                  <a:tab algn="l" pos="1909800"/>
                  <a:tab algn="l" pos="2546280"/>
                  <a:tab algn="l" pos="3182760"/>
                  <a:tab algn="l" pos="3819600"/>
                  <a:tab algn="l" pos="4456080"/>
                  <a:tab algn="l" pos="5092560"/>
                  <a:tab algn="l" pos="5729400"/>
                  <a:tab algn="l" pos="6365880"/>
                  <a:tab algn="l" pos="7002360"/>
                  <a:tab algn="l" pos="7639200"/>
                  <a:tab algn="l" pos="8275680"/>
                  <a:tab algn="l" pos="8912160"/>
                  <a:tab algn="l" pos="9548640"/>
                  <a:tab algn="l" pos="10185480"/>
                  <a:tab algn="l" pos="10821960"/>
                </a:tabLst>
              </a:pP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Rectangle 115"/>
            <p:cNvSpPr/>
            <p:nvPr/>
          </p:nvSpPr>
          <p:spPr>
            <a:xfrm>
              <a:off x="4394520" y="3802680"/>
              <a:ext cx="255960" cy="99720"/>
            </a:xfrm>
            <a:prstGeom prst="rect">
              <a:avLst/>
            </a:prstGeom>
            <a:noFill/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636480"/>
                  <a:tab algn="l" pos="1273320"/>
                  <a:tab algn="l" pos="1909800"/>
                  <a:tab algn="l" pos="2546280"/>
                  <a:tab algn="l" pos="3182760"/>
                  <a:tab algn="l" pos="3819600"/>
                  <a:tab algn="l" pos="4456080"/>
                  <a:tab algn="l" pos="5092560"/>
                  <a:tab algn="l" pos="5729400"/>
                  <a:tab algn="l" pos="6365880"/>
                  <a:tab algn="l" pos="7002360"/>
                  <a:tab algn="l" pos="7639200"/>
                  <a:tab algn="l" pos="8275680"/>
                  <a:tab algn="l" pos="8912160"/>
                  <a:tab algn="l" pos="9548640"/>
                  <a:tab algn="l" pos="10185480"/>
                  <a:tab algn="l" pos="10821960"/>
                </a:tabLst>
              </a:pP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Freeform 116"/>
            <p:cNvSpPr/>
            <p:nvPr/>
          </p:nvSpPr>
          <p:spPr>
            <a:xfrm>
              <a:off x="4570920" y="3387600"/>
              <a:ext cx="246600" cy="442800"/>
            </a:xfrm>
            <a:prstGeom prst="pie">
              <a:avLst/>
            </a:prstGeom>
            <a:noFill/>
            <a:ln w="28440">
              <a:solidFill>
                <a:srgbClr val="7030a0"/>
              </a:solidFill>
              <a:prstDash val="sysDash"/>
              <a:miter/>
              <a:tailEnd len="med" type="triangle" w="med"/>
            </a:ln>
            <a:effectLst>
              <a:outerShdw dist="38183" dir="2700000" blurRad="0" rotWithShape="0">
                <a:srgbClr val="80808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636480"/>
                  <a:tab algn="l" pos="1273320"/>
                  <a:tab algn="l" pos="1909800"/>
                  <a:tab algn="l" pos="2546280"/>
                  <a:tab algn="l" pos="3182760"/>
                  <a:tab algn="l" pos="3819600"/>
                  <a:tab algn="l" pos="4456080"/>
                  <a:tab algn="l" pos="5092560"/>
                  <a:tab algn="l" pos="5729400"/>
                  <a:tab algn="l" pos="6365880"/>
                  <a:tab algn="l" pos="7002360"/>
                  <a:tab algn="l" pos="7639200"/>
                  <a:tab algn="l" pos="8275680"/>
                  <a:tab algn="l" pos="8912160"/>
                  <a:tab algn="l" pos="9548640"/>
                  <a:tab algn="l" pos="10185480"/>
                  <a:tab algn="l" pos="10821960"/>
                </a:tabLst>
              </a:pP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TextBox 117"/>
            <p:cNvSpPr/>
            <p:nvPr/>
          </p:nvSpPr>
          <p:spPr>
            <a:xfrm>
              <a:off x="4744440" y="3353760"/>
              <a:ext cx="4780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636480"/>
                  <a:tab algn="l" pos="1273320"/>
                  <a:tab algn="l" pos="1909800"/>
                  <a:tab algn="l" pos="2546280"/>
                  <a:tab algn="l" pos="3182760"/>
                  <a:tab algn="l" pos="3819600"/>
                  <a:tab algn="l" pos="4456080"/>
                  <a:tab algn="l" pos="5092560"/>
                  <a:tab algn="l" pos="5729400"/>
                  <a:tab algn="l" pos="6365880"/>
                  <a:tab algn="l" pos="7002360"/>
                  <a:tab algn="l" pos="7639200"/>
                  <a:tab algn="l" pos="8275680"/>
                  <a:tab algn="l" pos="8912160"/>
                  <a:tab algn="l" pos="9548640"/>
                  <a:tab algn="l" pos="10185480"/>
                  <a:tab algn="l" pos="10821960"/>
                </a:tabLst>
              </a:pPr>
              <a:r>
                <a:rPr b="1" lang="en-US" sz="900" spc="-1" strike="noStrike">
                  <a:solidFill>
                    <a:srgbClr val="4f81bd"/>
                  </a:solidFill>
                  <a:latin typeface="Calibri"/>
                </a:rPr>
                <a:t>Jan 1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TextBox 118"/>
            <p:cNvSpPr/>
            <p:nvPr/>
          </p:nvSpPr>
          <p:spPr>
            <a:xfrm>
              <a:off x="4204800" y="3630960"/>
              <a:ext cx="4780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636480"/>
                  <a:tab algn="l" pos="1273320"/>
                  <a:tab algn="l" pos="1909800"/>
                  <a:tab algn="l" pos="2546280"/>
                  <a:tab algn="l" pos="3182760"/>
                  <a:tab algn="l" pos="3819600"/>
                  <a:tab algn="l" pos="4456080"/>
                  <a:tab algn="l" pos="5092560"/>
                  <a:tab algn="l" pos="5729400"/>
                  <a:tab algn="l" pos="6365880"/>
                  <a:tab algn="l" pos="7002360"/>
                  <a:tab algn="l" pos="7639200"/>
                  <a:tab algn="l" pos="8275680"/>
                  <a:tab algn="l" pos="8912160"/>
                  <a:tab algn="l" pos="9548640"/>
                  <a:tab algn="l" pos="10185480"/>
                  <a:tab algn="l" pos="10821960"/>
                </a:tabLst>
              </a:pPr>
              <a:r>
                <a:rPr b="1" lang="en-US" sz="900" spc="-1" strike="noStrike">
                  <a:solidFill>
                    <a:srgbClr val="7030a0"/>
                  </a:solidFill>
                  <a:latin typeface="Calibri"/>
                </a:rPr>
                <a:t>Jan 19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TextBox 119"/>
            <p:cNvSpPr/>
            <p:nvPr/>
          </p:nvSpPr>
          <p:spPr>
            <a:xfrm>
              <a:off x="3637440" y="2400840"/>
              <a:ext cx="56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636480"/>
                  <a:tab algn="l" pos="1273320"/>
                  <a:tab algn="l" pos="1909800"/>
                  <a:tab algn="l" pos="2546280"/>
                  <a:tab algn="l" pos="3182760"/>
                  <a:tab algn="l" pos="3819600"/>
                  <a:tab algn="l" pos="4456080"/>
                  <a:tab algn="l" pos="5092560"/>
                  <a:tab algn="l" pos="5729400"/>
                  <a:tab algn="l" pos="6365880"/>
                  <a:tab algn="l" pos="7002360"/>
                  <a:tab algn="l" pos="7639200"/>
                  <a:tab algn="l" pos="8275680"/>
                  <a:tab algn="l" pos="8912160"/>
                  <a:tab algn="l" pos="9548640"/>
                  <a:tab algn="l" pos="10185480"/>
                  <a:tab algn="l" pos="10821960"/>
                </a:tabLst>
              </a:pPr>
              <a:r>
                <a:rPr b="1" lang="en-US" sz="900" spc="-1" strike="noStrike">
                  <a:solidFill>
                    <a:srgbClr val="4f81bd"/>
                  </a:solidFill>
                  <a:latin typeface="Calibri"/>
                </a:rPr>
                <a:t>Jan 6 - 8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TextBox 120"/>
            <p:cNvSpPr/>
            <p:nvPr/>
          </p:nvSpPr>
          <p:spPr>
            <a:xfrm>
              <a:off x="747360" y="2669040"/>
              <a:ext cx="564840" cy="27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700"/>
                </a:lnSpc>
                <a:tabLst>
                  <a:tab algn="l" pos="0"/>
                  <a:tab algn="l" pos="636480"/>
                  <a:tab algn="l" pos="1273320"/>
                  <a:tab algn="l" pos="1909800"/>
                  <a:tab algn="l" pos="2546280"/>
                  <a:tab algn="l" pos="3182760"/>
                  <a:tab algn="l" pos="3819600"/>
                  <a:tab algn="l" pos="4456080"/>
                  <a:tab algn="l" pos="5092560"/>
                  <a:tab algn="l" pos="5729400"/>
                  <a:tab algn="l" pos="6365880"/>
                  <a:tab algn="l" pos="7002360"/>
                  <a:tab algn="l" pos="7639200"/>
                  <a:tab algn="l" pos="8275680"/>
                  <a:tab algn="l" pos="8912160"/>
                  <a:tab algn="l" pos="9548640"/>
                  <a:tab algn="l" pos="10185480"/>
                  <a:tab algn="l" pos="1082196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Calibri"/>
                </a:rPr>
                <a:t>late Dec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ts val="700"/>
                </a:lnSpc>
                <a:tabLst>
                  <a:tab algn="l" pos="0"/>
                  <a:tab algn="l" pos="636480"/>
                  <a:tab algn="l" pos="1273320"/>
                  <a:tab algn="l" pos="1909800"/>
                  <a:tab algn="l" pos="2546280"/>
                  <a:tab algn="l" pos="3182760"/>
                  <a:tab algn="l" pos="3819600"/>
                  <a:tab algn="l" pos="4456080"/>
                  <a:tab algn="l" pos="5092560"/>
                  <a:tab algn="l" pos="5729400"/>
                  <a:tab algn="l" pos="6365880"/>
                  <a:tab algn="l" pos="7002360"/>
                  <a:tab algn="l" pos="7639200"/>
                  <a:tab algn="l" pos="8275680"/>
                  <a:tab algn="l" pos="8912160"/>
                  <a:tab algn="l" pos="9548640"/>
                  <a:tab algn="l" pos="10185480"/>
                  <a:tab algn="l" pos="1082196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Calibri"/>
                </a:rPr>
                <a:t>201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Rectangle 121"/>
            <p:cNvSpPr/>
            <p:nvPr/>
          </p:nvSpPr>
          <p:spPr>
            <a:xfrm>
              <a:off x="804960" y="420480"/>
              <a:ext cx="1272960" cy="53316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636480"/>
                  <a:tab algn="l" pos="1273320"/>
                  <a:tab algn="l" pos="1909800"/>
                  <a:tab algn="l" pos="2546280"/>
                  <a:tab algn="l" pos="3182760"/>
                  <a:tab algn="l" pos="3819600"/>
                  <a:tab algn="l" pos="4456080"/>
                  <a:tab algn="l" pos="5092560"/>
                  <a:tab algn="l" pos="5729400"/>
                  <a:tab algn="l" pos="6365880"/>
                  <a:tab algn="l" pos="7002360"/>
                  <a:tab algn="l" pos="7639200"/>
                  <a:tab algn="l" pos="8275680"/>
                  <a:tab algn="l" pos="8912160"/>
                  <a:tab algn="l" pos="9548640"/>
                  <a:tab algn="l" pos="10185480"/>
                  <a:tab algn="l" pos="10821960"/>
                </a:tabLst>
              </a:pP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Straight Connector 122"/>
            <p:cNvSpPr/>
            <p:nvPr/>
          </p:nvSpPr>
          <p:spPr>
            <a:xfrm flipV="1">
              <a:off x="320400" y="424800"/>
              <a:ext cx="481320" cy="1248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Straight Connector 123"/>
            <p:cNvSpPr/>
            <p:nvPr/>
          </p:nvSpPr>
          <p:spPr>
            <a:xfrm>
              <a:off x="2078280" y="429120"/>
              <a:ext cx="3893040" cy="1241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TextBox 124"/>
            <p:cNvSpPr/>
            <p:nvPr/>
          </p:nvSpPr>
          <p:spPr>
            <a:xfrm>
              <a:off x="3163680" y="4239720"/>
              <a:ext cx="3239280" cy="779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636480"/>
                  <a:tab algn="l" pos="1273320"/>
                  <a:tab algn="l" pos="1909800"/>
                  <a:tab algn="l" pos="2546280"/>
                  <a:tab algn="l" pos="3182760"/>
                  <a:tab algn="l" pos="3819600"/>
                  <a:tab algn="l" pos="4456080"/>
                  <a:tab algn="l" pos="5092560"/>
                  <a:tab algn="l" pos="5729400"/>
                  <a:tab algn="l" pos="6365880"/>
                  <a:tab algn="l" pos="7002360"/>
                  <a:tab algn="l" pos="7639200"/>
                  <a:tab algn="l" pos="8275680"/>
                  <a:tab algn="l" pos="8912160"/>
                  <a:tab algn="l" pos="9548640"/>
                  <a:tab algn="l" pos="10185480"/>
                  <a:tab algn="l" pos="1082196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G-1442 route from Mabineh 1 to Waterloo in late December 201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636480"/>
                  <a:tab algn="l" pos="1273320"/>
                  <a:tab algn="l" pos="1909800"/>
                  <a:tab algn="l" pos="2546280"/>
                  <a:tab algn="l" pos="3182760"/>
                  <a:tab algn="l" pos="3819600"/>
                  <a:tab algn="l" pos="4456080"/>
                  <a:tab algn="l" pos="5092560"/>
                  <a:tab algn="l" pos="5729400"/>
                  <a:tab algn="l" pos="6365880"/>
                  <a:tab algn="l" pos="7002360"/>
                  <a:tab algn="l" pos="7639200"/>
                  <a:tab algn="l" pos="8275680"/>
                  <a:tab algn="l" pos="8912160"/>
                  <a:tab algn="l" pos="9548640"/>
                  <a:tab algn="l" pos="10185480"/>
                  <a:tab algn="l" pos="1082196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G-1442 route from Waterloo to Masingbi in late December 201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636480"/>
                  <a:tab algn="l" pos="1273320"/>
                  <a:tab algn="l" pos="1909800"/>
                  <a:tab algn="l" pos="2546280"/>
                  <a:tab algn="l" pos="3182760"/>
                  <a:tab algn="l" pos="3819600"/>
                  <a:tab algn="l" pos="4456080"/>
                  <a:tab algn="l" pos="5092560"/>
                  <a:tab algn="l" pos="5729400"/>
                  <a:tab algn="l" pos="6365880"/>
                  <a:tab algn="l" pos="7002360"/>
                  <a:tab algn="l" pos="7639200"/>
                  <a:tab algn="l" pos="8275680"/>
                  <a:tab algn="l" pos="8912160"/>
                  <a:tab algn="l" pos="9548640"/>
                  <a:tab algn="l" pos="10185480"/>
                  <a:tab algn="l" pos="1082196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G-1442 route from Masingbi to Mabineh 1 in early January 2011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636480"/>
                  <a:tab algn="l" pos="1273320"/>
                  <a:tab algn="l" pos="1909800"/>
                  <a:tab algn="l" pos="2546280"/>
                  <a:tab algn="l" pos="3182760"/>
                  <a:tab algn="l" pos="3819600"/>
                  <a:tab algn="l" pos="4456080"/>
                  <a:tab algn="l" pos="5092560"/>
                  <a:tab algn="l" pos="5729400"/>
                  <a:tab algn="l" pos="6365880"/>
                  <a:tab algn="l" pos="7002360"/>
                  <a:tab algn="l" pos="7639200"/>
                  <a:tab algn="l" pos="8275680"/>
                  <a:tab algn="l" pos="8912160"/>
                  <a:tab algn="l" pos="9548640"/>
                  <a:tab algn="l" pos="10185480"/>
                  <a:tab algn="l" pos="1082196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G-1442 route from Mabineh 1 to Tongo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636480"/>
                  <a:tab algn="l" pos="1273320"/>
                  <a:tab algn="l" pos="1909800"/>
                  <a:tab algn="l" pos="2546280"/>
                  <a:tab algn="l" pos="3182760"/>
                  <a:tab algn="l" pos="3819600"/>
                  <a:tab algn="l" pos="4456080"/>
                  <a:tab algn="l" pos="5092560"/>
                  <a:tab algn="l" pos="5729400"/>
                  <a:tab algn="l" pos="6365880"/>
                  <a:tab algn="l" pos="7002360"/>
                  <a:tab algn="l" pos="7639200"/>
                  <a:tab algn="l" pos="8275680"/>
                  <a:tab algn="l" pos="8912160"/>
                  <a:tab algn="l" pos="9548640"/>
                  <a:tab algn="l" pos="10185480"/>
                  <a:tab algn="l" pos="1082196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G-1442 route from Tongo to Kenema (KGH maternity ward)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Straight Connector 125"/>
            <p:cNvSpPr/>
            <p:nvPr/>
          </p:nvSpPr>
          <p:spPr>
            <a:xfrm>
              <a:off x="2818080" y="4347720"/>
              <a:ext cx="342720" cy="0"/>
            </a:xfrm>
            <a:prstGeom prst="line">
              <a:avLst/>
            </a:prstGeom>
            <a:ln w="25560">
              <a:solidFill>
                <a:srgbClr val="00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Straight Connector 126"/>
            <p:cNvSpPr/>
            <p:nvPr/>
          </p:nvSpPr>
          <p:spPr>
            <a:xfrm>
              <a:off x="2818080" y="4712040"/>
              <a:ext cx="342720" cy="0"/>
            </a:xfrm>
            <a:prstGeom prst="line">
              <a:avLst/>
            </a:prstGeom>
            <a:ln w="28440">
              <a:solidFill>
                <a:srgbClr val="558ed5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Straight Connector 127"/>
            <p:cNvSpPr/>
            <p:nvPr/>
          </p:nvSpPr>
          <p:spPr>
            <a:xfrm>
              <a:off x="2818080" y="4468320"/>
              <a:ext cx="342720" cy="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Straight Connector 128"/>
            <p:cNvSpPr/>
            <p:nvPr/>
          </p:nvSpPr>
          <p:spPr>
            <a:xfrm>
              <a:off x="2818080" y="4590720"/>
              <a:ext cx="342720" cy="0"/>
            </a:xfrm>
            <a:prstGeom prst="line">
              <a:avLst/>
            </a:prstGeom>
            <a:ln w="25560">
              <a:solidFill>
                <a:srgbClr val="984807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Straight Connector 129"/>
            <p:cNvSpPr/>
            <p:nvPr/>
          </p:nvSpPr>
          <p:spPr>
            <a:xfrm>
              <a:off x="2818080" y="4834440"/>
              <a:ext cx="342720" cy="0"/>
            </a:xfrm>
            <a:prstGeom prst="line">
              <a:avLst/>
            </a:prstGeom>
            <a:ln w="25560">
              <a:solidFill>
                <a:srgbClr val="7030a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TextBox 130"/>
            <p:cNvSpPr/>
            <p:nvPr/>
          </p:nvSpPr>
          <p:spPr>
            <a:xfrm rot="17821800">
              <a:off x="5516280" y="2598840"/>
              <a:ext cx="517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636480"/>
                  <a:tab algn="l" pos="1273320"/>
                  <a:tab algn="l" pos="1909800"/>
                  <a:tab algn="l" pos="2546280"/>
                  <a:tab algn="l" pos="3182760"/>
                  <a:tab algn="l" pos="3819600"/>
                  <a:tab algn="l" pos="4456080"/>
                  <a:tab algn="l" pos="5092560"/>
                  <a:tab algn="l" pos="5729400"/>
                  <a:tab algn="l" pos="6365880"/>
                  <a:tab algn="l" pos="7002360"/>
                  <a:tab algn="l" pos="7639200"/>
                  <a:tab algn="l" pos="8275680"/>
                  <a:tab algn="l" pos="8912160"/>
                  <a:tab algn="l" pos="9548640"/>
                  <a:tab algn="l" pos="10185480"/>
                  <a:tab algn="l" pos="10821960"/>
                </a:tabLst>
              </a:pPr>
              <a:r>
                <a:rPr b="1" lang="en-US" sz="900" spc="-1" strike="noStrike">
                  <a:solidFill>
                    <a:srgbClr val="595959"/>
                  </a:solidFill>
                  <a:latin typeface="Calibri"/>
                </a:rPr>
                <a:t>Guinea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TextBox 131"/>
            <p:cNvSpPr/>
            <p:nvPr/>
          </p:nvSpPr>
          <p:spPr>
            <a:xfrm rot="5400000">
              <a:off x="5577480" y="3642840"/>
              <a:ext cx="5007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636480"/>
                  <a:tab algn="l" pos="1273320"/>
                  <a:tab algn="l" pos="1909800"/>
                  <a:tab algn="l" pos="2546280"/>
                  <a:tab algn="l" pos="3182760"/>
                  <a:tab algn="l" pos="3819600"/>
                  <a:tab algn="l" pos="4456080"/>
                  <a:tab algn="l" pos="5092560"/>
                  <a:tab algn="l" pos="5729400"/>
                  <a:tab algn="l" pos="6365880"/>
                  <a:tab algn="l" pos="7002360"/>
                  <a:tab algn="l" pos="7639200"/>
                  <a:tab algn="l" pos="8275680"/>
                  <a:tab algn="l" pos="8912160"/>
                  <a:tab algn="l" pos="9548640"/>
                  <a:tab algn="l" pos="10185480"/>
                  <a:tab algn="l" pos="10821960"/>
                </a:tabLst>
              </a:pPr>
              <a:r>
                <a:rPr b="1" lang="en-US" sz="900" spc="-1" strike="noStrike">
                  <a:solidFill>
                    <a:srgbClr val="595959"/>
                  </a:solidFill>
                  <a:latin typeface="Calibri"/>
                </a:rPr>
                <a:t>Liberia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TextBox 132"/>
            <p:cNvSpPr/>
            <p:nvPr/>
          </p:nvSpPr>
          <p:spPr>
            <a:xfrm>
              <a:off x="-19800" y="-69840"/>
              <a:ext cx="32400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636480"/>
                  <a:tab algn="l" pos="1273320"/>
                  <a:tab algn="l" pos="1909800"/>
                  <a:tab algn="l" pos="2546280"/>
                  <a:tab algn="l" pos="3182760"/>
                  <a:tab algn="l" pos="3819600"/>
                  <a:tab algn="l" pos="4456080"/>
                  <a:tab algn="l" pos="5092560"/>
                  <a:tab algn="l" pos="5729400"/>
                  <a:tab algn="l" pos="6365880"/>
                  <a:tab algn="l" pos="7002360"/>
                  <a:tab algn="l" pos="7639200"/>
                  <a:tab algn="l" pos="8275680"/>
                  <a:tab algn="l" pos="8912160"/>
                  <a:tab algn="l" pos="9548640"/>
                  <a:tab algn="l" pos="10185480"/>
                  <a:tab algn="l" pos="1082196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Calibri"/>
                </a:rPr>
                <a:t>A.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78" name="Picture 3" descr=""/>
            <p:cNvPicPr/>
            <p:nvPr/>
          </p:nvPicPr>
          <p:blipFill>
            <a:blip r:embed="rId3"/>
            <a:stretch/>
          </p:blipFill>
          <p:spPr>
            <a:xfrm>
              <a:off x="2459160" y="1440"/>
              <a:ext cx="1371960" cy="1366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9" name="TextBox 134"/>
            <p:cNvSpPr/>
            <p:nvPr/>
          </p:nvSpPr>
          <p:spPr>
            <a:xfrm>
              <a:off x="3130200" y="1965960"/>
              <a:ext cx="5997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636480"/>
                  <a:tab algn="l" pos="1273320"/>
                  <a:tab algn="l" pos="1909800"/>
                  <a:tab algn="l" pos="2546280"/>
                  <a:tab algn="l" pos="3182760"/>
                  <a:tab algn="l" pos="3819600"/>
                  <a:tab algn="l" pos="4456080"/>
                  <a:tab algn="l" pos="5092560"/>
                  <a:tab algn="l" pos="5729400"/>
                  <a:tab algn="l" pos="6365880"/>
                  <a:tab algn="l" pos="7002360"/>
                  <a:tab algn="l" pos="7639200"/>
                  <a:tab algn="l" pos="8275680"/>
                  <a:tab algn="l" pos="8912160"/>
                  <a:tab algn="l" pos="9548640"/>
                  <a:tab algn="l" pos="10185480"/>
                  <a:tab algn="l" pos="1082196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Calibri"/>
                </a:rPr>
                <a:t>early Jan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636480"/>
                  <a:tab algn="l" pos="1273320"/>
                  <a:tab algn="l" pos="1909800"/>
                  <a:tab algn="l" pos="2546280"/>
                  <a:tab algn="l" pos="3182760"/>
                  <a:tab algn="l" pos="3819600"/>
                  <a:tab algn="l" pos="4456080"/>
                  <a:tab algn="l" pos="5092560"/>
                  <a:tab algn="l" pos="5729400"/>
                  <a:tab algn="l" pos="6365880"/>
                  <a:tab algn="l" pos="7002360"/>
                  <a:tab algn="l" pos="7639200"/>
                  <a:tab algn="l" pos="8275680"/>
                  <a:tab algn="l" pos="8912160"/>
                  <a:tab algn="l" pos="9548640"/>
                  <a:tab algn="l" pos="10185480"/>
                  <a:tab algn="l" pos="1082196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Calibri"/>
                </a:rPr>
                <a:t>2011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5-Point Star 135"/>
            <p:cNvSpPr/>
            <p:nvPr/>
          </p:nvSpPr>
          <p:spPr>
            <a:xfrm>
              <a:off x="3589920" y="2258280"/>
              <a:ext cx="36360" cy="36360"/>
            </a:xfrm>
            <a:prstGeom prst="pie">
              <a:avLst/>
            </a:prstGeom>
            <a:solidFill>
              <a:srgbClr val="ff0000"/>
            </a:solidFill>
            <a:ln w="255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ctr">
              <a:noAutofit/>
            </a:bodyPr>
            <a:p>
              <a:pPr algn="ctr">
                <a:tabLst>
                  <a:tab algn="l" pos="0"/>
                  <a:tab algn="l" pos="636480"/>
                  <a:tab algn="l" pos="1273320"/>
                  <a:tab algn="l" pos="1909800"/>
                  <a:tab algn="l" pos="2546280"/>
                  <a:tab algn="l" pos="3182760"/>
                  <a:tab algn="l" pos="3819600"/>
                  <a:tab algn="l" pos="4456080"/>
                  <a:tab algn="l" pos="5092560"/>
                  <a:tab algn="l" pos="5729400"/>
                  <a:tab algn="l" pos="6365880"/>
                  <a:tab algn="l" pos="7002360"/>
                  <a:tab algn="l" pos="7639200"/>
                  <a:tab algn="l" pos="8275680"/>
                  <a:tab algn="l" pos="8912160"/>
                  <a:tab algn="l" pos="9548640"/>
                  <a:tab algn="l" pos="10185480"/>
                  <a:tab algn="l" pos="10821960"/>
                </a:tabLst>
              </a:pP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5-Point Star 136"/>
            <p:cNvSpPr/>
            <p:nvPr/>
          </p:nvSpPr>
          <p:spPr>
            <a:xfrm>
              <a:off x="1502640" y="560880"/>
              <a:ext cx="36360" cy="36360"/>
            </a:xfrm>
            <a:prstGeom prst="pie">
              <a:avLst/>
            </a:prstGeom>
            <a:solidFill>
              <a:srgbClr val="ff0000"/>
            </a:solidFill>
            <a:ln w="255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ctr">
              <a:noAutofit/>
            </a:bodyPr>
            <a:p>
              <a:pPr algn="ctr">
                <a:tabLst>
                  <a:tab algn="l" pos="0"/>
                  <a:tab algn="l" pos="636480"/>
                  <a:tab algn="l" pos="1273320"/>
                  <a:tab algn="l" pos="1909800"/>
                  <a:tab algn="l" pos="2546280"/>
                  <a:tab algn="l" pos="3182760"/>
                  <a:tab algn="l" pos="3819600"/>
                  <a:tab algn="l" pos="4456080"/>
                  <a:tab algn="l" pos="5092560"/>
                  <a:tab algn="l" pos="5729400"/>
                  <a:tab algn="l" pos="6365880"/>
                  <a:tab algn="l" pos="7002360"/>
                  <a:tab algn="l" pos="7639200"/>
                  <a:tab algn="l" pos="8275680"/>
                  <a:tab algn="l" pos="8912160"/>
                  <a:tab algn="l" pos="9548640"/>
                  <a:tab algn="l" pos="10185480"/>
                  <a:tab algn="l" pos="10821960"/>
                </a:tabLst>
              </a:pP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5-Point Star 137"/>
            <p:cNvSpPr/>
            <p:nvPr/>
          </p:nvSpPr>
          <p:spPr>
            <a:xfrm>
              <a:off x="3135960" y="558360"/>
              <a:ext cx="36360" cy="36360"/>
            </a:xfrm>
            <a:prstGeom prst="pie">
              <a:avLst/>
            </a:prstGeom>
            <a:solidFill>
              <a:srgbClr val="ff0000"/>
            </a:solidFill>
            <a:ln w="255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ctr">
              <a:noAutofit/>
            </a:bodyPr>
            <a:p>
              <a:pPr algn="ctr">
                <a:tabLst>
                  <a:tab algn="l" pos="0"/>
                  <a:tab algn="l" pos="636480"/>
                  <a:tab algn="l" pos="1273320"/>
                  <a:tab algn="l" pos="1909800"/>
                  <a:tab algn="l" pos="2546280"/>
                  <a:tab algn="l" pos="3182760"/>
                  <a:tab algn="l" pos="3819600"/>
                  <a:tab algn="l" pos="4456080"/>
                  <a:tab algn="l" pos="5092560"/>
                  <a:tab algn="l" pos="5729400"/>
                  <a:tab algn="l" pos="6365880"/>
                  <a:tab algn="l" pos="7002360"/>
                  <a:tab algn="l" pos="7639200"/>
                  <a:tab algn="l" pos="8275680"/>
                  <a:tab algn="l" pos="8912160"/>
                  <a:tab algn="l" pos="9548640"/>
                  <a:tab algn="l" pos="10185480"/>
                  <a:tab algn="l" pos="10821960"/>
                </a:tabLst>
              </a:pP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TextBox 138"/>
            <p:cNvSpPr/>
            <p:nvPr/>
          </p:nvSpPr>
          <p:spPr>
            <a:xfrm>
              <a:off x="2403720" y="-66240"/>
              <a:ext cx="31788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636480"/>
                  <a:tab algn="l" pos="1273320"/>
                  <a:tab algn="l" pos="1909800"/>
                  <a:tab algn="l" pos="2546280"/>
                  <a:tab algn="l" pos="3182760"/>
                  <a:tab algn="l" pos="3819600"/>
                  <a:tab algn="l" pos="4456080"/>
                  <a:tab algn="l" pos="5092560"/>
                  <a:tab algn="l" pos="5729400"/>
                  <a:tab algn="l" pos="6365880"/>
                  <a:tab algn="l" pos="7002360"/>
                  <a:tab algn="l" pos="7639200"/>
                  <a:tab algn="l" pos="8275680"/>
                  <a:tab algn="l" pos="8912160"/>
                  <a:tab algn="l" pos="9548640"/>
                  <a:tab algn="l" pos="10185480"/>
                  <a:tab algn="l" pos="1082196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Calibri"/>
                </a:rPr>
                <a:t>B.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TextBox 139"/>
            <p:cNvSpPr/>
            <p:nvPr/>
          </p:nvSpPr>
          <p:spPr>
            <a:xfrm>
              <a:off x="-3240" y="1558440"/>
              <a:ext cx="31176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636480"/>
                  <a:tab algn="l" pos="1273320"/>
                  <a:tab algn="l" pos="1909800"/>
                  <a:tab algn="l" pos="2546280"/>
                  <a:tab algn="l" pos="3182760"/>
                  <a:tab algn="l" pos="3819600"/>
                  <a:tab algn="l" pos="4456080"/>
                  <a:tab algn="l" pos="5092560"/>
                  <a:tab algn="l" pos="5729400"/>
                  <a:tab algn="l" pos="6365880"/>
                  <a:tab algn="l" pos="7002360"/>
                  <a:tab algn="l" pos="7639200"/>
                  <a:tab algn="l" pos="8275680"/>
                  <a:tab algn="l" pos="8912160"/>
                  <a:tab algn="l" pos="9548640"/>
                  <a:tab algn="l" pos="10185480"/>
                  <a:tab algn="l" pos="1082196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Calibri"/>
                </a:rPr>
                <a:t>C.</a:t>
              </a:r>
              <a:endParaRPr b="0" lang="en-US" sz="13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3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1-27T11:29:16Z</dcterms:created>
  <dc:creator>Luis Branco</dc:creator>
  <dc:description/>
  <dc:language>en-US</dc:language>
  <cp:lastModifiedBy>Jessica Grove</cp:lastModifiedBy>
  <dcterms:modified xsi:type="dcterms:W3CDTF">2011-08-09T16:33:32Z</dcterms:modified>
  <cp:revision>18</cp:revision>
  <dc:subject/>
  <dc:title>Slide 1</dc:title>
</cp:coreProperties>
</file>